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0EB96-54E3-A9CD-9FF1-E99D65295B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6F41B5-3AFD-AEBC-FA2B-D33C9EF70A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A1FA72-CFC6-7729-7DB8-CA49A0B60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6B61A-A6DA-6846-35F3-18C9E4062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700556-9B8C-C06C-1118-ED9433DF6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825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FE97F-D76A-26F6-23EE-FBD6AC9214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506672-AF9A-F667-D848-3E609528D5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73C466-072E-BAB7-6208-1D5107A7E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90F784-A10B-0FE1-AE55-EE1C827FA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3419A-70E3-A1A2-B54F-D3C83E1EB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441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9D01B3-7E2F-2694-E8C7-76C3FBCEFA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CA8F2E-9D1A-574D-5FD6-FBC1CA82F2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768EA3-FCA1-31D9-7066-1DA351ED0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D9CF5-3101-EE6E-C2CD-211CBB8E9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706B2-6D31-0A1C-9813-6B57009AC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668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FC8CDE-DA7A-4367-574F-1071EF1DB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DEEC9F-A0EB-F379-2F97-471C1518F7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AAC1C-8C7E-A065-AABC-EF31183D9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87B487-E51D-39B5-8828-F950AA36D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63FBA-494D-34C4-4341-597D45B2B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0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B52204-4156-0D4A-FA32-95F14C679E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EF9364-4C78-2C41-A984-8D5CA54CEB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475185-D704-EBE6-A156-A278FDBC5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C70B4A-07D3-65A7-F52F-8FBA12DF6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9D59B-CBD7-300C-B831-1A57F86F8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914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25AA32-BB26-C040-62CA-19E8BF5D1F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6379FE-3A9A-8C29-E355-616C5D5534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B0AFF4-659E-A215-3F5F-AD5EDD98B2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BEE5D1-8396-36DE-80FA-41456B36B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06FD72-E0C1-7A89-C8CE-537CA4C9D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839065-46A8-13A4-4705-25DE5635E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613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22720C-C855-D6A7-A4D4-C142CA7EB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EBCB83-3B2E-1627-1530-F1DCDCBE9C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91E0BF-179A-79A4-A1DA-01E0BCDFC5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57EA23-30FE-4753-45B2-BE39880F52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ECF816-99FB-25BA-BAE7-76B0F64F72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E4E32A-2776-1920-0956-ABD1F8AE6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112DF9-DA54-56FB-888F-A941A8348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B54139-1383-0F66-BA8E-3F5AE6D76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250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EC603-2B29-D94A-5E71-B2F6BCF6A4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D92046-3D15-7C43-E43F-7C6ED0D07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336B68-7A9E-E521-F7CB-C596CBE18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0B624A-C8D8-0997-FEA1-7345355F4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642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0CF96F-49BD-69D7-FB42-B319687F8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F4CCBC-AA55-DC1B-F5BB-F5E42807D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31292E-DE32-C62E-233A-92F6FF2CE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106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45517-35CB-0929-12C3-963AD45E4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97175F-2BF8-D057-E231-A11A1CB537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9B74AA-0476-7347-37E8-E744D97866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041693-BF7F-FD48-D7D7-6A569DBEA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E57153-2575-6D44-977C-3E8EA3B40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2476A7-65BC-F4AD-A295-BC841394D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584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5C281-D9B1-56F5-C109-CB5AA3EBA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CA3526-FFE8-1304-0A62-173A13C90B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D8B311-0F65-E807-DB13-19230965D0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60E3D6-4D6C-B94E-97B0-BDC0975DB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F2227-BEE1-D022-F5AC-BE5E7820D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F6B65-1C8A-2B62-7852-49C42FD98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300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DEF846-F67C-BAE5-252B-44FC54C4EE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1F6193-3DED-CDAE-6F6C-EA013B5E45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86E32-2A6B-9818-050C-1AD61B4984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237084-2C15-8A4B-B9F8-F76D30836846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410392-8624-6866-0A9A-83564C6ECF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7C55A-D5B6-1AC9-94EA-CCDBA40227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BC266A-045D-B643-8445-F4E504D1F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167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1B34DF6F-60BA-D961-627A-B1C7B5E34741}"/>
              </a:ext>
            </a:extLst>
          </p:cNvPr>
          <p:cNvSpPr txBox="1"/>
          <p:nvPr/>
        </p:nvSpPr>
        <p:spPr>
          <a:xfrm>
            <a:off x="153429" y="6147651"/>
            <a:ext cx="12038571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6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DH status class comparison, differentially expressed proteins. </a:t>
            </a:r>
            <a:r>
              <a:rPr lang="en-US" sz="1200" b="1" dirty="0"/>
              <a:t>A</a:t>
            </a:r>
            <a:r>
              <a:rPr lang="en-US" sz="1200" dirty="0"/>
              <a:t>. IDH status and outcome,  Overall survival  (left panel) and Progression free survival (right panel). IDH status was not statistically significant for either outcome measure, although exhibiting expected trend. Only 4 patients were IDH mutated. </a:t>
            </a:r>
            <a:r>
              <a:rPr lang="en-US" sz="1200" b="1" dirty="0"/>
              <a:t>B</a:t>
            </a:r>
            <a:r>
              <a:rPr lang="en-US" sz="1200" dirty="0"/>
              <a:t>. Proteomic differences were observed between classes both pre CRT (21 proteins) and in alteration pre. vs. post CRT (15 proteins). Pre CRT signal is illustrated in (</a:t>
            </a:r>
            <a:r>
              <a:rPr lang="en-US" sz="1200" b="1" dirty="0"/>
              <a:t>C</a:t>
            </a:r>
            <a:r>
              <a:rPr lang="en-US" sz="1200" dirty="0"/>
              <a:t>) and alteration with CRT in (</a:t>
            </a:r>
            <a:r>
              <a:rPr lang="en-US" sz="1200" b="1" dirty="0"/>
              <a:t>D</a:t>
            </a:r>
            <a:r>
              <a:rPr lang="en-US" sz="1200" dirty="0"/>
              <a:t>)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1BE8AD-D339-A8AB-9D77-B233A88A26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174" y="224924"/>
            <a:ext cx="11234213" cy="5768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126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03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3</cp:revision>
  <dcterms:created xsi:type="dcterms:W3CDTF">2025-10-28T19:53:19Z</dcterms:created>
  <dcterms:modified xsi:type="dcterms:W3CDTF">2025-10-28T20:29:57Z</dcterms:modified>
</cp:coreProperties>
</file>